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6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14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6" Type="http://schemas.openxmlformats.org/officeDocument/2006/relationships/image" Target="../media/image6.wmf"/><Relationship Id="rId5" Type="http://schemas.openxmlformats.org/officeDocument/2006/relationships/image" Target="../media/image5.wmf"/><Relationship Id="rId4" Type="http://schemas.openxmlformats.org/officeDocument/2006/relationships/image" Target="../media/image4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3E0512-0268-4FF8-8802-79EFC082039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383F9E6-7144-4515-8E86-06E688673A2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7A6FE8-94F0-427E-BDBB-8653FD4B9B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35605-C9D2-42AB-BB0A-B9E6D03B0EF9}" type="datetimeFigureOut">
              <a:rPr lang="en-US" smtClean="0"/>
              <a:t>10/9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45A65B-2AF6-4353-89CA-D741E349A7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22B1E6-AA21-4634-97DF-CB7C681DC9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E0E809-9B26-4D7E-B50F-A4930A655F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09922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8DC013-85A8-4246-9BC9-FAF1ECAC96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2017D90-CF1B-4304-ABA1-05267E5A5EC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362961-7979-4AE1-A8BE-C97E26292D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35605-C9D2-42AB-BB0A-B9E6D03B0EF9}" type="datetimeFigureOut">
              <a:rPr lang="en-US" smtClean="0"/>
              <a:t>10/9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6D28D0-A760-4F19-9E56-5AD2201C35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BAD04E-8607-4FAF-96BB-8A8B530760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E0E809-9B26-4D7E-B50F-A4930A655F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25012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05C9590-3962-41A2-98D7-0E78AE2FF96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1750DD8-6135-4671-B2A2-874787E402F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DFFCD3-8C7E-4CC9-961E-E6004E81EA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35605-C9D2-42AB-BB0A-B9E6D03B0EF9}" type="datetimeFigureOut">
              <a:rPr lang="en-US" smtClean="0"/>
              <a:t>10/9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244ED2-09E2-4F8C-BC67-1F2DD63E1C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D275A0-0C3E-48CB-BB91-4CFF008080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E0E809-9B26-4D7E-B50F-A4930A655F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73932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A8BA97-0371-45BB-BAE5-1347D51B4D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FA65F62-5BE8-4515-9198-4704023D275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52C5A0-3619-4C38-9DBF-85BEC39244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35605-C9D2-42AB-BB0A-B9E6D03B0EF9}" type="datetimeFigureOut">
              <a:rPr lang="en-US" smtClean="0"/>
              <a:t>10/9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6E324F-54E8-48E8-9B29-33C86B005B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62C033A-F879-4511-A251-1559292ED8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E0E809-9B26-4D7E-B50F-A4930A655F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74401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212FA3-B2CC-43D8-AFE4-6ADF27639D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460D71E-5DA4-4611-AC62-0C4815E5993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973F8E-A9AD-4CD5-AEDB-9C8DA9252C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35605-C9D2-42AB-BB0A-B9E6D03B0EF9}" type="datetimeFigureOut">
              <a:rPr lang="en-US" smtClean="0"/>
              <a:t>10/9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D6C16D-F5C7-40CC-A302-E89478F06E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0696A0-0D0F-4B1E-86D6-7DC7AB5072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E0E809-9B26-4D7E-B50F-A4930A655F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30254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121102-FFAE-4E08-8FB6-0F69F8BFDC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6E7B8C3-DC4D-4EAD-8A63-6A6F198E1AA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19C127D-BA41-4A03-B30D-B478B4B9059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0F4911C-2A1A-4D19-83C8-1368259214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35605-C9D2-42AB-BB0A-B9E6D03B0EF9}" type="datetimeFigureOut">
              <a:rPr lang="en-US" smtClean="0"/>
              <a:t>10/9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0281621-3B39-4A71-9647-B35D6F2325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76F7135-75B4-482D-B684-37CF56289B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E0E809-9B26-4D7E-B50F-A4930A655F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68359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BD5A97-B3A4-4E5A-90C5-382714B43B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631C041-CC69-4C60-8109-6FE380D5E7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84A4EB9-9475-4480-A873-AC9FBBB7065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5FDF499-B58C-4178-8714-FFEC5AF6AF2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F135C2B-174A-4F43-8EAF-3172A18E16C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CEA139D-539C-4975-8CB1-CA10C7E281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35605-C9D2-42AB-BB0A-B9E6D03B0EF9}" type="datetimeFigureOut">
              <a:rPr lang="en-US" smtClean="0"/>
              <a:t>10/9/2018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206BBB3-C75E-4D0B-A280-CB3C431E99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15585C8-3523-4043-9D06-0F971EAFA1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E0E809-9B26-4D7E-B50F-A4930A655F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91135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169713-CE26-4EA5-A66F-4C6256A9EB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1B0E28E-EA6F-49F5-B55D-1C904DB6D8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35605-C9D2-42AB-BB0A-B9E6D03B0EF9}" type="datetimeFigureOut">
              <a:rPr lang="en-US" smtClean="0"/>
              <a:t>10/9/2018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C2ADDD6-36DF-4CBC-BD7D-F3B0CE9F3B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CC14AE4-1F87-45CA-ACAC-54EC8A0462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E0E809-9B26-4D7E-B50F-A4930A655F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52024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336650E-57E3-4705-BD5C-CF7A00DCED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35605-C9D2-42AB-BB0A-B9E6D03B0EF9}" type="datetimeFigureOut">
              <a:rPr lang="en-US" smtClean="0"/>
              <a:t>10/9/2018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884EA28-A914-4909-9C0D-495E13FD68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285DB44-8F24-44B1-AE83-B4AEB24089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E0E809-9B26-4D7E-B50F-A4930A655F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54087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397B86-D6F9-4FF2-8782-FFDF27408B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7265E41-2FEC-463F-8F2A-D2BBC192AB1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5FD17BD-DBF5-4A83-BF4F-26AC25E9F93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59AD5E1-398C-4298-8C79-6F00D28B10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35605-C9D2-42AB-BB0A-B9E6D03B0EF9}" type="datetimeFigureOut">
              <a:rPr lang="en-US" smtClean="0"/>
              <a:t>10/9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9BEE0DF-A93A-4EFF-A9AB-1754B6254C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396AD8B-AE14-4462-9AC7-469463E9A7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E0E809-9B26-4D7E-B50F-A4930A655F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22596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18D022-B88C-4415-8C81-2E316EA696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BEA568A-9DFC-4479-9281-09B2EB6C3AA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64C591B-D5F8-436F-B847-C5C3E309B9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A21248D-1E78-4266-9967-0C8C5E6DDD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35605-C9D2-42AB-BB0A-B9E6D03B0EF9}" type="datetimeFigureOut">
              <a:rPr lang="en-US" smtClean="0"/>
              <a:t>10/9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73E08C9-4423-43A1-A9DE-9AA9AAA9D6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A4F91E0-035D-472A-B36D-31CF06A998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E0E809-9B26-4D7E-B50F-A4930A655F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65267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5B6E5A4-F3AB-434E-ADAD-B806FA9FD0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EE30166-556F-45D4-B0E6-E42917EF12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7AAAF1-B2B4-40F1-BAE6-DC5254C6614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B35605-C9D2-42AB-BB0A-B9E6D03B0EF9}" type="datetimeFigureOut">
              <a:rPr lang="en-US" smtClean="0"/>
              <a:t>10/9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4B346C-4349-4134-8D3B-D3A49C6F9EB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FA30F7-9F0C-4042-AC47-169FB7B7F6F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E0E809-9B26-4D7E-B50F-A4930A655F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54589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5.wmf"/><Relationship Id="rId3" Type="http://schemas.openxmlformats.org/officeDocument/2006/relationships/oleObject" Target="../embeddings/oleObject1.bin"/><Relationship Id="rId7" Type="http://schemas.openxmlformats.org/officeDocument/2006/relationships/image" Target="../media/image7.png"/><Relationship Id="rId12" Type="http://schemas.openxmlformats.org/officeDocument/2006/relationships/oleObject" Target="../embeddings/oleObject5.bin"/><Relationship Id="rId2" Type="http://schemas.openxmlformats.org/officeDocument/2006/relationships/slideLayout" Target="../slideLayouts/slideLayout1.xml"/><Relationship Id="rId16" Type="http://schemas.openxmlformats.org/officeDocument/2006/relationships/image" Target="../media/image8.png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11" Type="http://schemas.openxmlformats.org/officeDocument/2006/relationships/image" Target="../media/image4.wmf"/><Relationship Id="rId5" Type="http://schemas.openxmlformats.org/officeDocument/2006/relationships/oleObject" Target="../embeddings/oleObject2.bin"/><Relationship Id="rId15" Type="http://schemas.openxmlformats.org/officeDocument/2006/relationships/image" Target="../media/image6.wmf"/><Relationship Id="rId10" Type="http://schemas.openxmlformats.org/officeDocument/2006/relationships/oleObject" Target="../embeddings/oleObject4.bin"/><Relationship Id="rId4" Type="http://schemas.openxmlformats.org/officeDocument/2006/relationships/image" Target="../media/image1.wmf"/><Relationship Id="rId9" Type="http://schemas.openxmlformats.org/officeDocument/2006/relationships/image" Target="../media/image3.wmf"/><Relationship Id="rId14" Type="http://schemas.openxmlformats.org/officeDocument/2006/relationships/oleObject" Target="../embeddings/oleObject6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2C27A16D-0A6F-45D6-804A-19AA40358C07}"/>
              </a:ext>
            </a:extLst>
          </p:cNvPr>
          <p:cNvSpPr txBox="1"/>
          <p:nvPr/>
        </p:nvSpPr>
        <p:spPr>
          <a:xfrm>
            <a:off x="2510251" y="5056398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27</a:t>
            </a:r>
          </a:p>
        </p:txBody>
      </p:sp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88C4062C-944E-42BE-975A-A2C7D16B7DE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70402366"/>
              </p:ext>
            </p:extLst>
          </p:nvPr>
        </p:nvGraphicFramePr>
        <p:xfrm>
          <a:off x="3861291" y="3871051"/>
          <a:ext cx="1179513" cy="2270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53" name="Image" r:id="rId3" imgW="1179360" imgH="2270520" progId="Photoshop.Image.13">
                  <p:embed/>
                </p:oleObj>
              </mc:Choice>
              <mc:Fallback>
                <p:oleObj name="Image" r:id="rId3" imgW="1179360" imgH="227052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861291" y="3871051"/>
                        <a:ext cx="1179513" cy="22701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C58FD81F-5804-41BD-8308-1AC714F4DE8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83742371"/>
              </p:ext>
            </p:extLst>
          </p:nvPr>
        </p:nvGraphicFramePr>
        <p:xfrm>
          <a:off x="6505381" y="4088064"/>
          <a:ext cx="1200150" cy="1960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54" name="Image" r:id="rId5" imgW="1200600" imgH="1959840" progId="Photoshop.Image.13">
                  <p:embed/>
                </p:oleObj>
              </mc:Choice>
              <mc:Fallback>
                <p:oleObj name="Image" r:id="rId5" imgW="1200600" imgH="195984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505381" y="4088064"/>
                        <a:ext cx="1200150" cy="19605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mc:AlternateContent xmlns:mc="http://schemas.openxmlformats.org/markup-compatibility/2006" xmlns:a14="http://schemas.microsoft.com/office/drawing/2010/main">
        <mc:Choice Requires="a14"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18657183-872E-4FA0-86F1-6E275E1CCB9F}"/>
                  </a:ext>
                </a:extLst>
              </p:cNvPr>
              <p:cNvSpPr txBox="1"/>
              <p:nvPr/>
            </p:nvSpPr>
            <p:spPr>
              <a:xfrm>
                <a:off x="7730175" y="4884712"/>
                <a:ext cx="66236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14:m>
                  <m:oMath xmlns:m="http://schemas.openxmlformats.org/officeDocument/2006/math">
                    <m:r>
                      <m:rPr>
                        <m:sty m:val="p"/>
                      </m:rPr>
                      <a:rPr lang="el-GR" sz="1200" i="1" smtClean="0">
                        <a:latin typeface="Cambria Math" panose="02040503050406030204" pitchFamily="18" charset="0"/>
                      </a:rPr>
                      <m:t>β</m:t>
                    </m:r>
                  </m:oMath>
                </a14:m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</a:p>
            </p:txBody>
          </p:sp>
        </mc:Choice>
        <mc:Fallback xmlns=""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18657183-872E-4FA0-86F1-6E275E1CCB9F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7730175" y="4884712"/>
                <a:ext cx="662361" cy="276999"/>
              </a:xfrm>
              <a:prstGeom prst="rect">
                <a:avLst/>
              </a:prstGeom>
              <a:blipFill>
                <a:blip r:embed="rId7"/>
                <a:stretch>
                  <a:fillRect t="-2174" r="-917" b="-13043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12" name="TextBox 11">
            <a:extLst>
              <a:ext uri="{FF2B5EF4-FFF2-40B4-BE49-F238E27FC236}">
                <a16:creationId xmlns:a16="http://schemas.microsoft.com/office/drawing/2014/main" id="{8BD1950B-9DD0-4821-A600-94E6FC3A7739}"/>
              </a:ext>
            </a:extLst>
          </p:cNvPr>
          <p:cNvSpPr txBox="1"/>
          <p:nvPr/>
        </p:nvSpPr>
        <p:spPr>
          <a:xfrm>
            <a:off x="4962429" y="5146608"/>
            <a:ext cx="8402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yclin D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A97E729-249E-49C6-9D34-6B196EC7CB25}"/>
              </a:ext>
            </a:extLst>
          </p:cNvPr>
          <p:cNvSpPr txBox="1"/>
          <p:nvPr/>
        </p:nvSpPr>
        <p:spPr>
          <a:xfrm>
            <a:off x="5911264" y="5043978"/>
            <a:ext cx="6703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5EB5AED-3582-40BC-A966-A229F7CA8CDB}"/>
              </a:ext>
            </a:extLst>
          </p:cNvPr>
          <p:cNvSpPr txBox="1"/>
          <p:nvPr/>
        </p:nvSpPr>
        <p:spPr>
          <a:xfrm>
            <a:off x="5912655" y="4743980"/>
            <a:ext cx="6703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FB56B2C-FC51-4E7F-808F-F5D57E1928DB}"/>
              </a:ext>
            </a:extLst>
          </p:cNvPr>
          <p:cNvSpPr txBox="1"/>
          <p:nvPr/>
        </p:nvSpPr>
        <p:spPr>
          <a:xfrm>
            <a:off x="3227293" y="5324646"/>
            <a:ext cx="6703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595C65F-DB8C-48E2-A8D3-31104CFB9C8F}"/>
              </a:ext>
            </a:extLst>
          </p:cNvPr>
          <p:cNvSpPr txBox="1"/>
          <p:nvPr/>
        </p:nvSpPr>
        <p:spPr>
          <a:xfrm>
            <a:off x="3228684" y="5011948"/>
            <a:ext cx="6703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285B3A5-C49A-4F59-BD29-ADE345BF7028}"/>
              </a:ext>
            </a:extLst>
          </p:cNvPr>
          <p:cNvSpPr txBox="1"/>
          <p:nvPr/>
        </p:nvSpPr>
        <p:spPr>
          <a:xfrm>
            <a:off x="559972" y="5385250"/>
            <a:ext cx="6703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58E009F-0A7D-462F-A87C-4CFC583DB69A}"/>
              </a:ext>
            </a:extLst>
          </p:cNvPr>
          <p:cNvSpPr txBox="1"/>
          <p:nvPr/>
        </p:nvSpPr>
        <p:spPr>
          <a:xfrm>
            <a:off x="561363" y="4983652"/>
            <a:ext cx="6703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9" name="Object 18">
            <a:extLst>
              <a:ext uri="{FF2B5EF4-FFF2-40B4-BE49-F238E27FC236}">
                <a16:creationId xmlns:a16="http://schemas.microsoft.com/office/drawing/2014/main" id="{B156CCEF-C995-4498-BBF8-90F09E55E80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97155233"/>
              </p:ext>
            </p:extLst>
          </p:nvPr>
        </p:nvGraphicFramePr>
        <p:xfrm>
          <a:off x="1202536" y="3901215"/>
          <a:ext cx="1274763" cy="22669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55" name="Image" r:id="rId8" imgW="1274040" imgH="2267640" progId="Photoshop.Image.13">
                  <p:embed/>
                </p:oleObj>
              </mc:Choice>
              <mc:Fallback>
                <p:oleObj name="Image" r:id="rId8" imgW="1274040" imgH="226764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1202536" y="3901215"/>
                        <a:ext cx="1274763" cy="22669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Object 19">
            <a:extLst>
              <a:ext uri="{FF2B5EF4-FFF2-40B4-BE49-F238E27FC236}">
                <a16:creationId xmlns:a16="http://schemas.microsoft.com/office/drawing/2014/main" id="{4E3A6D2D-A99D-40E3-9386-0142130EAE7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12067320"/>
              </p:ext>
            </p:extLst>
          </p:nvPr>
        </p:nvGraphicFramePr>
        <p:xfrm>
          <a:off x="4096730" y="840613"/>
          <a:ext cx="996950" cy="1924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56" name="Image" r:id="rId10" imgW="996480" imgH="1737360" progId="Photoshop.Image.13">
                  <p:embed/>
                </p:oleObj>
              </mc:Choice>
              <mc:Fallback>
                <p:oleObj name="Image" r:id="rId10" imgW="996480" imgH="173736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4096730" y="840613"/>
                        <a:ext cx="996950" cy="19240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Object 20">
            <a:extLst>
              <a:ext uri="{FF2B5EF4-FFF2-40B4-BE49-F238E27FC236}">
                <a16:creationId xmlns:a16="http://schemas.microsoft.com/office/drawing/2014/main" id="{B66205BF-6BE4-4F66-949E-EB1A9E15B4C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14222831"/>
              </p:ext>
            </p:extLst>
          </p:nvPr>
        </p:nvGraphicFramePr>
        <p:xfrm>
          <a:off x="1345026" y="774871"/>
          <a:ext cx="1165225" cy="1924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57" name="Image" r:id="rId12" imgW="1165680" imgH="1659600" progId="Photoshop.Image.13">
                  <p:embed/>
                </p:oleObj>
              </mc:Choice>
              <mc:Fallback>
                <p:oleObj name="Image" r:id="rId12" imgW="1165680" imgH="165960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1345026" y="774871"/>
                        <a:ext cx="1165225" cy="19240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2" name="TextBox 21">
            <a:extLst>
              <a:ext uri="{FF2B5EF4-FFF2-40B4-BE49-F238E27FC236}">
                <a16:creationId xmlns:a16="http://schemas.microsoft.com/office/drawing/2014/main" id="{3DF352BA-92FC-4C3D-A59E-86BB242DEAE7}"/>
              </a:ext>
            </a:extLst>
          </p:cNvPr>
          <p:cNvSpPr txBox="1"/>
          <p:nvPr/>
        </p:nvSpPr>
        <p:spPr>
          <a:xfrm>
            <a:off x="2510251" y="1744359"/>
            <a:ext cx="5603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ax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DBA00CA6-F0F4-4148-A060-3F2AF1E3548A}"/>
              </a:ext>
            </a:extLst>
          </p:cNvPr>
          <p:cNvSpPr txBox="1"/>
          <p:nvPr/>
        </p:nvSpPr>
        <p:spPr>
          <a:xfrm>
            <a:off x="5093680" y="2274165"/>
            <a:ext cx="53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cl-2</a:t>
            </a:r>
          </a:p>
        </p:txBody>
      </p:sp>
      <p:graphicFrame>
        <p:nvGraphicFramePr>
          <p:cNvPr id="24" name="Object 23">
            <a:extLst>
              <a:ext uri="{FF2B5EF4-FFF2-40B4-BE49-F238E27FC236}">
                <a16:creationId xmlns:a16="http://schemas.microsoft.com/office/drawing/2014/main" id="{AC870E80-5643-4380-9771-CAAAF4A129D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02088479"/>
              </p:ext>
            </p:extLst>
          </p:nvPr>
        </p:nvGraphicFramePr>
        <p:xfrm>
          <a:off x="6497176" y="801739"/>
          <a:ext cx="1316037" cy="22336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58" name="Image" r:id="rId14" imgW="1316520" imgH="2541960" progId="Photoshop.Image.13">
                  <p:embed/>
                </p:oleObj>
              </mc:Choice>
              <mc:Fallback>
                <p:oleObj name="Image" r:id="rId14" imgW="1316520" imgH="254196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6497176" y="801739"/>
                        <a:ext cx="1316037" cy="223361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mc:AlternateContent xmlns:mc="http://schemas.openxmlformats.org/markup-compatibility/2006" xmlns:a14="http://schemas.microsoft.com/office/drawing/2010/main">
        <mc:Choice Requires="a14"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E4222F9D-F68F-433A-B03B-FB389FC39EDB}"/>
                  </a:ext>
                </a:extLst>
              </p:cNvPr>
              <p:cNvSpPr txBox="1"/>
              <p:nvPr/>
            </p:nvSpPr>
            <p:spPr>
              <a:xfrm>
                <a:off x="7835170" y="1723557"/>
                <a:ext cx="66236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14:m>
                  <m:oMath xmlns:m="http://schemas.openxmlformats.org/officeDocument/2006/math">
                    <m:r>
                      <m:rPr>
                        <m:sty m:val="p"/>
                      </m:rPr>
                      <a:rPr lang="el-GR" sz="1200" i="1" smtClean="0">
                        <a:latin typeface="Cambria Math" panose="02040503050406030204" pitchFamily="18" charset="0"/>
                      </a:rPr>
                      <m:t>β</m:t>
                    </m:r>
                  </m:oMath>
                </a14:m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</a:p>
            </p:txBody>
          </p:sp>
        </mc:Choice>
        <mc:Fallback xmlns=""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E4222F9D-F68F-433A-B03B-FB389FC39EDB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7835170" y="1723557"/>
                <a:ext cx="662361" cy="276999"/>
              </a:xfrm>
              <a:prstGeom prst="rect">
                <a:avLst/>
              </a:prstGeom>
              <a:blipFill>
                <a:blip r:embed="rId16"/>
                <a:stretch>
                  <a:fillRect t="-4444" r="-917" b="-15556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26" name="TextBox 25">
            <a:extLst>
              <a:ext uri="{FF2B5EF4-FFF2-40B4-BE49-F238E27FC236}">
                <a16:creationId xmlns:a16="http://schemas.microsoft.com/office/drawing/2014/main" id="{E407E50A-6EA8-49F0-93E8-A8A9DDDCFEFC}"/>
              </a:ext>
            </a:extLst>
          </p:cNvPr>
          <p:cNvSpPr txBox="1"/>
          <p:nvPr/>
        </p:nvSpPr>
        <p:spPr>
          <a:xfrm>
            <a:off x="5829350" y="1905285"/>
            <a:ext cx="6703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2F742D4-4074-4BE1-A1EC-744C69329450}"/>
              </a:ext>
            </a:extLst>
          </p:cNvPr>
          <p:cNvSpPr txBox="1"/>
          <p:nvPr/>
        </p:nvSpPr>
        <p:spPr>
          <a:xfrm>
            <a:off x="5830741" y="1516387"/>
            <a:ext cx="6703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05CA1E6-297E-4DF9-B8AD-279C8B63315D}"/>
              </a:ext>
            </a:extLst>
          </p:cNvPr>
          <p:cNvSpPr txBox="1"/>
          <p:nvPr/>
        </p:nvSpPr>
        <p:spPr>
          <a:xfrm>
            <a:off x="3468158" y="2374455"/>
            <a:ext cx="6703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1FDDF271-A5C3-4B39-AFC1-DA01D80CB2AE}"/>
              </a:ext>
            </a:extLst>
          </p:cNvPr>
          <p:cNvSpPr txBox="1"/>
          <p:nvPr/>
        </p:nvSpPr>
        <p:spPr>
          <a:xfrm>
            <a:off x="3450576" y="2096919"/>
            <a:ext cx="6703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F826983-E7BE-4B0B-89CA-DDEB374063CC}"/>
              </a:ext>
            </a:extLst>
          </p:cNvPr>
          <p:cNvSpPr txBox="1"/>
          <p:nvPr/>
        </p:nvSpPr>
        <p:spPr>
          <a:xfrm>
            <a:off x="685969" y="2407375"/>
            <a:ext cx="6703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1E2FFDA-1E9E-4F83-BAF4-6F258DCC3A44}"/>
              </a:ext>
            </a:extLst>
          </p:cNvPr>
          <p:cNvSpPr txBox="1"/>
          <p:nvPr/>
        </p:nvSpPr>
        <p:spPr>
          <a:xfrm>
            <a:off x="687360" y="1751777"/>
            <a:ext cx="6703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A573F926-E083-4E6C-976D-DEE83F80970B}"/>
              </a:ext>
            </a:extLst>
          </p:cNvPr>
          <p:cNvSpPr txBox="1"/>
          <p:nvPr/>
        </p:nvSpPr>
        <p:spPr>
          <a:xfrm>
            <a:off x="1317979" y="3669935"/>
            <a:ext cx="10438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    2    3    4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C97866CF-A80D-4EC7-9E61-4986830E13E1}"/>
              </a:ext>
            </a:extLst>
          </p:cNvPr>
          <p:cNvSpPr txBox="1"/>
          <p:nvPr/>
        </p:nvSpPr>
        <p:spPr>
          <a:xfrm>
            <a:off x="3929109" y="3619005"/>
            <a:ext cx="10438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    2    3    4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B541CB2A-CF1B-4560-84E0-54B8B733FAB2}"/>
              </a:ext>
            </a:extLst>
          </p:cNvPr>
          <p:cNvSpPr txBox="1"/>
          <p:nvPr/>
        </p:nvSpPr>
        <p:spPr>
          <a:xfrm>
            <a:off x="6543333" y="3828835"/>
            <a:ext cx="10438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    2    3    4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4FED69F6-B425-4589-B967-A4A266D29D04}"/>
              </a:ext>
            </a:extLst>
          </p:cNvPr>
          <p:cNvSpPr txBox="1"/>
          <p:nvPr/>
        </p:nvSpPr>
        <p:spPr>
          <a:xfrm>
            <a:off x="4073267" y="583054"/>
            <a:ext cx="10438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    2    3    4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95F42FE0-6DC5-4CA0-9700-1FDD96B20A9B}"/>
              </a:ext>
            </a:extLst>
          </p:cNvPr>
          <p:cNvSpPr txBox="1"/>
          <p:nvPr/>
        </p:nvSpPr>
        <p:spPr>
          <a:xfrm>
            <a:off x="1405700" y="524740"/>
            <a:ext cx="10438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    2   3    4 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CEF5EDE1-E4AC-41F6-9B27-A17DCC3E7D6D}"/>
              </a:ext>
            </a:extLst>
          </p:cNvPr>
          <p:cNvSpPr txBox="1"/>
          <p:nvPr/>
        </p:nvSpPr>
        <p:spPr>
          <a:xfrm>
            <a:off x="6531233" y="559747"/>
            <a:ext cx="10438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    2    3    4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2099854" y="60801"/>
            <a:ext cx="80122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Western blots:  Lane 1 = Control, Lane 2 = Res, Lane 3 = TRAIL, Lane 4 = Res + TRAIL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098669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44</TotalTime>
  <Words>81</Words>
  <Application>Microsoft Office PowerPoint</Application>
  <PresentationFormat>Widescreen</PresentationFormat>
  <Paragraphs>25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Cambria Math</vt:lpstr>
      <vt:lpstr>Office Theme</vt:lpstr>
      <vt:lpstr>Imag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kesh Srivastava</dc:creator>
  <cp:lastModifiedBy>Srivastava, Rakesh K.</cp:lastModifiedBy>
  <cp:revision>22</cp:revision>
  <dcterms:created xsi:type="dcterms:W3CDTF">2018-10-07T17:51:38Z</dcterms:created>
  <dcterms:modified xsi:type="dcterms:W3CDTF">2018-10-09T18:44:47Z</dcterms:modified>
</cp:coreProperties>
</file>